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712"/>
  </p:normalViewPr>
  <p:slideViewPr>
    <p:cSldViewPr snapToGrid="0" snapToObjects="1">
      <p:cViewPr varScale="1">
        <p:scale>
          <a:sx n="107" d="100"/>
          <a:sy n="107" d="100"/>
        </p:scale>
        <p:origin x="1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83BEFC-5D6A-584E-BC28-3D624BB71A9D}" type="datetimeFigureOut">
              <a:rPr lang="en-US" smtClean="0"/>
              <a:t>1/5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F44B73-67F5-9C46-BBE5-84DC1D014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487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presentative images of larvae</a:t>
            </a:r>
            <a:r>
              <a:rPr lang="en-US" baseline="0" dirty="0" smtClean="0"/>
              <a:t> scored as runx1 high or runx1 low.  Raw numbers for each of 5 biological </a:t>
            </a:r>
            <a:r>
              <a:rPr lang="en-US" baseline="0" smtClean="0"/>
              <a:t>replicates performed </a:t>
            </a:r>
            <a:r>
              <a:rPr lang="en-US" baseline="0" dirty="0" smtClean="0"/>
              <a:t>from separate cross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12ACAB0-07D4-E448-A949-E0ABD4E4D5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7116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569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455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780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9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540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430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864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433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6100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913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561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A2E5B-7207-9B41-AB02-2226962A67C0}" type="datetimeFigureOut">
              <a:rPr lang="en-US" smtClean="0"/>
              <a:t>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D0808-2716-1A4D-8C76-6C380CE08C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893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48279" y="2842053"/>
          <a:ext cx="11923035" cy="376285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1980"/>
                <a:gridCol w="475193"/>
                <a:gridCol w="597548"/>
                <a:gridCol w="597548"/>
                <a:gridCol w="597548"/>
                <a:gridCol w="597548"/>
                <a:gridCol w="597548"/>
                <a:gridCol w="597548"/>
                <a:gridCol w="597548"/>
                <a:gridCol w="597548"/>
                <a:gridCol w="571099"/>
                <a:gridCol w="623995"/>
                <a:gridCol w="597548"/>
                <a:gridCol w="597548"/>
                <a:gridCol w="597548"/>
                <a:gridCol w="597548"/>
                <a:gridCol w="597548"/>
                <a:gridCol w="597548"/>
                <a:gridCol w="597548"/>
                <a:gridCol w="597548"/>
              </a:tblGrid>
              <a:tr h="248087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sk-SK" sz="800" u="none" strike="noStrike" dirty="0">
                          <a:effectLst/>
                        </a:rPr>
                        <a:t> </a:t>
                      </a:r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sibling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tet2/3 double mutant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1084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00" u="none" strike="noStrike" dirty="0">
                          <a:effectLst/>
                        </a:rPr>
                        <a:t>total embryo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uninjec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wt-te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OGT mutant te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uninjec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wt-te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OGT mutant te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</a:tr>
              <a:tr h="278592">
                <a:tc vMerge="1">
                  <a:txBody>
                    <a:bodyPr/>
                    <a:lstStyle/>
                    <a:p>
                      <a:pPr algn="ctr" fontAlgn="b"/>
                      <a:endParaRPr lang="sk-SK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tot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unx1 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% hig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ot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unx1 hig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% hig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tot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unx1 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% 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tot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unx1 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% 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tot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unx1 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% 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tot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runx1 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% 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3468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Experiment 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u="none" strike="noStrike" dirty="0">
                          <a:effectLst/>
                        </a:rPr>
                        <a:t>117</a:t>
                      </a:r>
                      <a:endParaRPr lang="cs-CZ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 dirty="0">
                          <a:effectLst/>
                        </a:rPr>
                        <a:t>29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7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93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8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6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93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8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 dirty="0">
                          <a:effectLst/>
                        </a:rPr>
                        <a:t>25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89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1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29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67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33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3468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Experiment 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 dirty="0">
                          <a:effectLst/>
                        </a:rPr>
                        <a:t>207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u="none" strike="noStrike" dirty="0">
                          <a:effectLst/>
                        </a:rPr>
                        <a:t>39</a:t>
                      </a:r>
                      <a:endParaRPr lang="uk-U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3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97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000" u="none" strike="noStrike" dirty="0">
                          <a:effectLst/>
                        </a:rPr>
                        <a:t>58</a:t>
                      </a:r>
                      <a:endParaRPr lang="ru-R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000" u="none" strike="noStrike">
                          <a:effectLst/>
                        </a:rPr>
                        <a:t>57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98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95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2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18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53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33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3468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Experiment 3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15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u="none" strike="noStrike">
                          <a:effectLst/>
                        </a:rPr>
                        <a:t>18</a:t>
                      </a:r>
                      <a:endParaRPr lang="fi-FI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1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89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5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93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u="none" strike="noStrike">
                          <a:effectLst/>
                        </a:rPr>
                        <a:t>49</a:t>
                      </a:r>
                      <a:endParaRPr lang="cs-CZ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92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40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50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12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33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3468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Experiment 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105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0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0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100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2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u="none" strike="noStrike" dirty="0">
                          <a:effectLst/>
                        </a:rPr>
                        <a:t>21</a:t>
                      </a:r>
                      <a:endParaRPr lang="cs-CZ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95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3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 dirty="0">
                          <a:effectLst/>
                        </a:rPr>
                        <a:t>32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91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33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67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31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3468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Experiment 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u="none" strike="noStrike">
                          <a:effectLst/>
                        </a:rPr>
                        <a:t>119</a:t>
                      </a:r>
                      <a:endParaRPr lang="cs-CZ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6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5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96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4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4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100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 dirty="0">
                          <a:effectLst/>
                        </a:rPr>
                        <a:t>29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94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 dirty="0">
                          <a:effectLst/>
                        </a:rPr>
                        <a:t>20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30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75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1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57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3468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combine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70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132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tr-TR" sz="1000" u="none" strike="noStrike" dirty="0">
                          <a:effectLst/>
                        </a:rPr>
                        <a:t>126</a:t>
                      </a:r>
                      <a:endParaRPr lang="tr-T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95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u="none" strike="noStrike" dirty="0">
                          <a:effectLst/>
                        </a:rPr>
                        <a:t>186</a:t>
                      </a:r>
                      <a:endParaRPr lang="fi-FI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178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96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>
                          <a:effectLst/>
                        </a:rPr>
                        <a:t>203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u="none" strike="noStrike">
                          <a:effectLst/>
                        </a:rPr>
                        <a:t>188</a:t>
                      </a:r>
                      <a:endParaRPr lang="fi-FI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93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7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u="none" strike="noStrike" dirty="0">
                          <a:effectLst/>
                        </a:rPr>
                        <a:t>21</a:t>
                      </a:r>
                      <a:endParaRPr lang="cs-CZ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28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4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 dirty="0">
                          <a:effectLst/>
                        </a:rPr>
                        <a:t>24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59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 dirty="0">
                          <a:effectLst/>
                        </a:rPr>
                        <a:t>66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u="none" strike="noStrike" dirty="0">
                          <a:effectLst/>
                        </a:rPr>
                        <a:t>25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38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3468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Averag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>
                          <a:effectLst/>
                        </a:rPr>
                        <a:t> </a:t>
                      </a:r>
                      <a:endParaRPr lang="sk-SK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>
                          <a:effectLst/>
                        </a:rPr>
                        <a:t> </a:t>
                      </a:r>
                      <a:endParaRPr lang="sk-SK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95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>
                          <a:effectLst/>
                        </a:rPr>
                        <a:t> </a:t>
                      </a:r>
                      <a:endParaRPr lang="sk-SK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>
                          <a:effectLst/>
                        </a:rPr>
                        <a:t> </a:t>
                      </a:r>
                      <a:endParaRPr lang="sk-SK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96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92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>
                          <a:effectLst/>
                        </a:rPr>
                        <a:t> </a:t>
                      </a:r>
                      <a:endParaRPr lang="sk-SK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30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62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38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3468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standard erro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>
                          <a:effectLst/>
                        </a:rPr>
                        <a:t> </a:t>
                      </a:r>
                      <a:endParaRPr lang="sk-SK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2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>
                          <a:effectLst/>
                        </a:rPr>
                        <a:t> </a:t>
                      </a:r>
                      <a:endParaRPr lang="sk-SK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>
                          <a:effectLst/>
                        </a:rPr>
                        <a:t> </a:t>
                      </a:r>
                      <a:endParaRPr lang="sk-SK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1.50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1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>
                          <a:effectLst/>
                        </a:rPr>
                        <a:t>3.50%</a:t>
                      </a:r>
                      <a:endParaRPr lang="mr-IN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4.70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u="none" strike="noStrike" dirty="0">
                          <a:effectLst/>
                        </a:rPr>
                        <a:t>4.90%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044" marR="4044" marT="404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10912" t="28828" r="6948" b="18739"/>
          <a:stretch/>
        </p:blipFill>
        <p:spPr>
          <a:xfrm>
            <a:off x="4156932" y="741280"/>
            <a:ext cx="2907748" cy="182754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11792" t="17837" r="6054" b="29730"/>
          <a:stretch/>
        </p:blipFill>
        <p:spPr>
          <a:xfrm>
            <a:off x="819769" y="727545"/>
            <a:ext cx="2907747" cy="1827548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>
            <a:off x="148279" y="5572897"/>
            <a:ext cx="11923035" cy="0"/>
          </a:xfrm>
          <a:prstGeom prst="line">
            <a:avLst/>
          </a:prstGeom>
          <a:ln w="285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689392" y="385683"/>
            <a:ext cx="1226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unx1 high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053377" y="399438"/>
            <a:ext cx="1114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unx1 low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7170742" y="173547"/>
            <a:ext cx="50212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le 3: Analysis of zebrafish larvae</a:t>
            </a:r>
            <a:endParaRPr lang="en-US" dirty="0" smtClean="0"/>
          </a:p>
          <a:p>
            <a:r>
              <a:rPr lang="en-US" dirty="0" smtClean="0"/>
              <a:t>A) Representative images of larvae with high and low </a:t>
            </a:r>
            <a:r>
              <a:rPr lang="en-US" i="1" dirty="0" smtClean="0"/>
              <a:t>runx1</a:t>
            </a:r>
            <a:r>
              <a:rPr lang="en-US" dirty="0" smtClean="0"/>
              <a:t> expression. B) Embryo numbers and scoring for all 5 biological replicates.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48279" y="245645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B</a:t>
            </a:r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144271" y="35821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A</a:t>
            </a:r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7695210" y="25592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2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288</Words>
  <Application>Microsoft Macintosh PowerPoint</Application>
  <PresentationFormat>Widescreen</PresentationFormat>
  <Paragraphs>2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Mangal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l Hrit</dc:creator>
  <cp:lastModifiedBy>Joel Hrit</cp:lastModifiedBy>
  <cp:revision>3</cp:revision>
  <dcterms:created xsi:type="dcterms:W3CDTF">2018-01-05T00:22:15Z</dcterms:created>
  <dcterms:modified xsi:type="dcterms:W3CDTF">2018-01-05T18:13:52Z</dcterms:modified>
</cp:coreProperties>
</file>